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1" d="100"/>
          <a:sy n="51" d="100"/>
        </p:scale>
        <p:origin x="234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181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433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920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970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461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268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501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240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273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226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730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49B109-0941-461B-A96E-2F62C8387483}" type="datetimeFigureOut">
              <a:rPr lang="en-US" smtClean="0"/>
              <a:t>1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6BCD5-34B7-4DCE-BDBD-72FB8AF4D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298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929035" y="2021201"/>
          <a:ext cx="4754792" cy="985204"/>
        </p:xfrm>
        <a:graphic>
          <a:graphicData uri="http://schemas.openxmlformats.org/drawingml/2006/table">
            <a:tbl>
              <a:tblPr firstRow="1" firstCol="1" bandRow="1"/>
              <a:tblGrid>
                <a:gridCol w="1412950">
                  <a:extLst>
                    <a:ext uri="{9D8B030D-6E8A-4147-A177-3AD203B41FA5}">
                      <a16:colId xmlns:a16="http://schemas.microsoft.com/office/drawing/2014/main" val="3518405241"/>
                    </a:ext>
                  </a:extLst>
                </a:gridCol>
                <a:gridCol w="1871089">
                  <a:extLst>
                    <a:ext uri="{9D8B030D-6E8A-4147-A177-3AD203B41FA5}">
                      <a16:colId xmlns:a16="http://schemas.microsoft.com/office/drawing/2014/main" val="2783882854"/>
                    </a:ext>
                  </a:extLst>
                </a:gridCol>
                <a:gridCol w="1470753">
                  <a:extLst>
                    <a:ext uri="{9D8B030D-6E8A-4147-A177-3AD203B41FA5}">
                      <a16:colId xmlns:a16="http://schemas.microsoft.com/office/drawing/2014/main" val="4112357031"/>
                    </a:ext>
                  </a:extLst>
                </a:gridCol>
              </a:tblGrid>
              <a:tr h="223520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P-1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valonic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cid (µM)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5034582"/>
                  </a:ext>
                </a:extLst>
              </a:tr>
              <a:tr h="2235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 hours 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0</a:t>
                      </a:r>
                      <a:r>
                        <a:rPr lang="en-US" sz="11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°C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2 hours 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0</a:t>
                      </a:r>
                      <a:r>
                        <a:rPr lang="en-US" sz="11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°C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8268881"/>
                  </a:ext>
                </a:extLst>
              </a:tr>
              <a:tr h="10731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 ± 0.00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2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0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4308117"/>
                  </a:ext>
                </a:extLst>
              </a:tr>
              <a:tr h="11303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KD-HIDS #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41</a:t>
                      </a:r>
                      <a:r>
                        <a:rPr lang="en-US" sz="11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2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7</a:t>
                      </a:r>
                      <a:r>
                        <a:rPr lang="en-US" sz="11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1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7425805"/>
                  </a:ext>
                </a:extLst>
              </a:tr>
              <a:tr h="10731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KD-HIDS #B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71</a:t>
                      </a:r>
                      <a:r>
                        <a:rPr lang="en-US" sz="11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06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67</a:t>
                      </a:r>
                      <a:r>
                        <a:rPr lang="en-US" sz="11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± 0.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6633534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835516" y="1116781"/>
            <a:ext cx="4848311" cy="8828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.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valoni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id measured in supernatants of WT and MKD-HIDS THP-1 cells cultured for 24 or 72 hours at elevated temperature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°C). Data is shown as average of an experiment performed in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iplo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 SD, or as not detectable (ND)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8730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5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litiek, F.A. (Frouwkje)</dc:creator>
  <cp:lastModifiedBy>Politiek, F.A. (Frouwkje)</cp:lastModifiedBy>
  <cp:revision>2</cp:revision>
  <dcterms:created xsi:type="dcterms:W3CDTF">2024-01-26T20:42:06Z</dcterms:created>
  <dcterms:modified xsi:type="dcterms:W3CDTF">2024-01-29T19:07:39Z</dcterms:modified>
</cp:coreProperties>
</file>